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29.xml"/>
  <Override ContentType="application/vnd.openxmlformats-officedocument.presentationml.notesSlide+xml" PartName="/ppt/notesSlides/notesSlide32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28.xml"/>
  <Override ContentType="application/vnd.openxmlformats-officedocument.presentationml.notesSlide+xml" PartName="/ppt/notesSlides/notesSlide33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24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20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21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25.xml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0.xml"/>
  <Override ContentType="application/vnd.openxmlformats-officedocument.presentationml.notesSlide+xml" PartName="/ppt/notesSlides/notesSlide22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6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31.xml"/>
  <Override ContentType="application/vnd.openxmlformats-officedocument.presentationml.notesSlide+xml" PartName="/ppt/notesSlides/notesSlide19.xml"/>
  <Override ContentType="application/vnd.openxmlformats-officedocument.presentationml.notesSlide+xml" PartName="/ppt/notesSlides/notesSlide27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30.xml"/>
  <Override ContentType="application/vnd.openxmlformats-officedocument.presentationml.slide+xml" PartName="/ppt/slides/slide22.xml"/>
  <Override ContentType="application/vnd.openxmlformats-officedocument.presentationml.slide+xml" PartName="/ppt/slides/slide26.xml"/>
  <Override ContentType="application/vnd.openxmlformats-officedocument.presentationml.slide+xml" PartName="/ppt/slides/slide19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25.xml"/>
  <Override ContentType="application/vnd.openxmlformats-officedocument.presentationml.slide+xml" PartName="/ppt/slides/slide20.xml"/>
  <Override ContentType="application/vnd.openxmlformats-officedocument.presentationml.slide+xml" PartName="/ppt/slides/slide21.xml"/>
  <Override ContentType="application/vnd.openxmlformats-officedocument.presentationml.slide+xml" PartName="/ppt/slides/slide33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29.xml"/>
  <Override ContentType="application/vnd.openxmlformats-officedocument.presentationml.slide+xml" PartName="/ppt/slides/slide24.xml"/>
  <Override ContentType="application/vnd.openxmlformats-officedocument.presentationml.slide+xml" PartName="/ppt/slides/slide11.xml"/>
  <Override ContentType="application/vnd.openxmlformats-officedocument.presentationml.slide+xml" PartName="/ppt/slides/slide32.xml"/>
  <Override ContentType="application/vnd.openxmlformats-officedocument.presentationml.slide+xml" PartName="/ppt/slides/slide1.xml"/>
  <Override ContentType="application/vnd.openxmlformats-officedocument.presentationml.slide+xml" PartName="/ppt/slides/slide28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31.xml"/>
  <Override ContentType="application/vnd.openxmlformats-officedocument.presentationml.slide+xml" PartName="/ppt/slides/slide23.xml"/>
  <Override ContentType="application/vnd.openxmlformats-officedocument.presentationml.slide+xml" PartName="/ppt/slides/slide27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38" roundtripDataSignature="AMtx7mhc65qzNqGjhOqHgC2wEeW+BPJk2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6.xml"/><Relationship Id="rId22" Type="http://schemas.openxmlformats.org/officeDocument/2006/relationships/slide" Target="slides/slide18.xml"/><Relationship Id="rId21" Type="http://schemas.openxmlformats.org/officeDocument/2006/relationships/slide" Target="slides/slide17.xml"/><Relationship Id="rId24" Type="http://schemas.openxmlformats.org/officeDocument/2006/relationships/slide" Target="slides/slide20.xml"/><Relationship Id="rId23" Type="http://schemas.openxmlformats.org/officeDocument/2006/relationships/slide" Target="slides/slide19.xml"/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9" Type="http://schemas.openxmlformats.org/officeDocument/2006/relationships/slide" Target="slides/slide5.xml"/><Relationship Id="rId26" Type="http://schemas.openxmlformats.org/officeDocument/2006/relationships/slide" Target="slides/slide22.xml"/><Relationship Id="rId25" Type="http://schemas.openxmlformats.org/officeDocument/2006/relationships/slide" Target="slides/slide21.xml"/><Relationship Id="rId28" Type="http://schemas.openxmlformats.org/officeDocument/2006/relationships/slide" Target="slides/slide24.xml"/><Relationship Id="rId27" Type="http://schemas.openxmlformats.org/officeDocument/2006/relationships/slide" Target="slides/slide2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29" Type="http://schemas.openxmlformats.org/officeDocument/2006/relationships/slide" Target="slides/slide25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31" Type="http://schemas.openxmlformats.org/officeDocument/2006/relationships/slide" Target="slides/slide27.xml"/><Relationship Id="rId30" Type="http://schemas.openxmlformats.org/officeDocument/2006/relationships/slide" Target="slides/slide26.xml"/><Relationship Id="rId11" Type="http://schemas.openxmlformats.org/officeDocument/2006/relationships/slide" Target="slides/slide7.xml"/><Relationship Id="rId33" Type="http://schemas.openxmlformats.org/officeDocument/2006/relationships/slide" Target="slides/slide29.xml"/><Relationship Id="rId10" Type="http://schemas.openxmlformats.org/officeDocument/2006/relationships/slide" Target="slides/slide6.xml"/><Relationship Id="rId32" Type="http://schemas.openxmlformats.org/officeDocument/2006/relationships/slide" Target="slides/slide28.xml"/><Relationship Id="rId13" Type="http://schemas.openxmlformats.org/officeDocument/2006/relationships/slide" Target="slides/slide9.xml"/><Relationship Id="rId35" Type="http://schemas.openxmlformats.org/officeDocument/2006/relationships/slide" Target="slides/slide31.xml"/><Relationship Id="rId12" Type="http://schemas.openxmlformats.org/officeDocument/2006/relationships/slide" Target="slides/slide8.xml"/><Relationship Id="rId34" Type="http://schemas.openxmlformats.org/officeDocument/2006/relationships/slide" Target="slides/slide30.xml"/><Relationship Id="rId15" Type="http://schemas.openxmlformats.org/officeDocument/2006/relationships/slide" Target="slides/slide11.xml"/><Relationship Id="rId37" Type="http://schemas.openxmlformats.org/officeDocument/2006/relationships/slide" Target="slides/slide33.xml"/><Relationship Id="rId14" Type="http://schemas.openxmlformats.org/officeDocument/2006/relationships/slide" Target="slides/slide10.xml"/><Relationship Id="rId36" Type="http://schemas.openxmlformats.org/officeDocument/2006/relationships/slide" Target="slides/slide32.xml"/><Relationship Id="rId17" Type="http://schemas.openxmlformats.org/officeDocument/2006/relationships/slide" Target="slides/slide13.xml"/><Relationship Id="rId16" Type="http://schemas.openxmlformats.org/officeDocument/2006/relationships/slide" Target="slides/slide12.xml"/><Relationship Id="rId38" Type="http://customschemas.google.com/relationships/presentationmetadata" Target="metadata"/><Relationship Id="rId19" Type="http://schemas.openxmlformats.org/officeDocument/2006/relationships/slide" Target="slides/slide15.xml"/><Relationship Id="rId18" Type="http://schemas.openxmlformats.org/officeDocument/2006/relationships/slide" Target="slides/slide14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3628b36ef6a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3628b36ef6a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3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5" name="Google Shape;135;p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9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1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1" name="Google Shape;141;p1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6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1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8" name="Google Shape;148;p1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2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1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4" name="Google Shape;154;p1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58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1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0" name="Google Shape;160;p1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4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p1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6" name="Google Shape;166;p1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0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1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2" name="Google Shape;172;p1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6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1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8" name="Google Shape;178;p1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82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p1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84" name="Google Shape;184;p1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88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p1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0" name="Google Shape;190;p1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5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7" name="Google Shape;87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94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1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6" name="Google Shape;196;p1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0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Google Shape;201;p2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2" name="Google Shape;202;p2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6" name="Shape 2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Google Shape;207;p2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8" name="Google Shape;208;p2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2" name="Shape 2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Google Shape;213;p2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4" name="Google Shape;214;p2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8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2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0" name="Google Shape;220;p2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24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Google Shape;225;p2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6" name="Google Shape;226;p2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30" name="Shape 2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Google Shape;231;p2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2" name="Google Shape;232;p2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36" name="Shape 2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p2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8" name="Google Shape;238;p2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2" name="Shape 2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Google Shape;243;p2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4" name="Google Shape;244;p2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8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2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0" name="Google Shape;250;p2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3" name="Google Shape;93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54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2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6" name="Google Shape;256;p29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60" name="Shape 2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Google Shape;261;p3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62" name="Google Shape;262;p30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66" name="Shape 2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Google Shape;267;p3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68" name="Google Shape;268;p3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2" name="Shape 2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Google Shape;273;p3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74" name="Google Shape;274;p3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7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9" name="Google Shape;99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3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5" name="Google Shape;105;p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9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1" name="Google Shape;111;p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5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p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7" name="Google Shape;117;p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3" name="Google Shape;123;p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7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p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9" name="Google Shape;129;p8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4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43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4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4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4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44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44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4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4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4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5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35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3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3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3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36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3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3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3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37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37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3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3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3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3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38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38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3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3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3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39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39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39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39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39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3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3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3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40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4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4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4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4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41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41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4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4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4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42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42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42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4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4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4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33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3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3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3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3.png"/><Relationship Id="rId4" Type="http://schemas.openxmlformats.org/officeDocument/2006/relationships/image" Target="../media/image6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49.png"/><Relationship Id="rId4" Type="http://schemas.openxmlformats.org/officeDocument/2006/relationships/image" Target="../media/image2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6.png"/><Relationship Id="rId4" Type="http://schemas.openxmlformats.org/officeDocument/2006/relationships/image" Target="../media/image24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33.png"/><Relationship Id="rId4" Type="http://schemas.openxmlformats.org/officeDocument/2006/relationships/image" Target="../media/image23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21.png"/><Relationship Id="rId4" Type="http://schemas.openxmlformats.org/officeDocument/2006/relationships/image" Target="../media/image14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31.png"/><Relationship Id="rId4" Type="http://schemas.openxmlformats.org/officeDocument/2006/relationships/image" Target="../media/image44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43.png"/><Relationship Id="rId4" Type="http://schemas.openxmlformats.org/officeDocument/2006/relationships/image" Target="../media/image27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38.png"/><Relationship Id="rId4" Type="http://schemas.openxmlformats.org/officeDocument/2006/relationships/image" Target="../media/image28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41.png"/><Relationship Id="rId4" Type="http://schemas.openxmlformats.org/officeDocument/2006/relationships/image" Target="../media/image32.png"/></Relationships>
</file>

<file path=ppt/slides/_rels/slide1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9.xml"/><Relationship Id="rId3" Type="http://schemas.openxmlformats.org/officeDocument/2006/relationships/image" Target="../media/image30.png"/><Relationship Id="rId4" Type="http://schemas.openxmlformats.org/officeDocument/2006/relationships/image" Target="../media/image25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png"/><Relationship Id="rId4" Type="http://schemas.openxmlformats.org/officeDocument/2006/relationships/image" Target="../media/image15.png"/></Relationships>
</file>

<file path=ppt/slides/_rels/slide2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26.png"/><Relationship Id="rId4" Type="http://schemas.openxmlformats.org/officeDocument/2006/relationships/image" Target="../media/image45.png"/></Relationships>
</file>

<file path=ppt/slides/_rels/slide2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1.xml"/><Relationship Id="rId3" Type="http://schemas.openxmlformats.org/officeDocument/2006/relationships/image" Target="../media/image63.png"/><Relationship Id="rId4" Type="http://schemas.openxmlformats.org/officeDocument/2006/relationships/image" Target="../media/image37.png"/></Relationships>
</file>

<file path=ppt/slides/_rels/slide2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2.xml"/><Relationship Id="rId3" Type="http://schemas.openxmlformats.org/officeDocument/2006/relationships/image" Target="../media/image29.png"/><Relationship Id="rId4" Type="http://schemas.openxmlformats.org/officeDocument/2006/relationships/image" Target="../media/image39.png"/></Relationships>
</file>

<file path=ppt/slides/_rels/slide2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3.xml"/><Relationship Id="rId3" Type="http://schemas.openxmlformats.org/officeDocument/2006/relationships/image" Target="../media/image64.png"/><Relationship Id="rId4" Type="http://schemas.openxmlformats.org/officeDocument/2006/relationships/image" Target="../media/image40.png"/></Relationships>
</file>

<file path=ppt/slides/_rels/slide2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4.xml"/><Relationship Id="rId3" Type="http://schemas.openxmlformats.org/officeDocument/2006/relationships/image" Target="../media/image48.png"/><Relationship Id="rId4" Type="http://schemas.openxmlformats.org/officeDocument/2006/relationships/image" Target="../media/image35.png"/></Relationships>
</file>

<file path=ppt/slides/_rels/slide2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5.xml"/><Relationship Id="rId3" Type="http://schemas.openxmlformats.org/officeDocument/2006/relationships/image" Target="../media/image36.png"/><Relationship Id="rId4" Type="http://schemas.openxmlformats.org/officeDocument/2006/relationships/image" Target="../media/image34.png"/></Relationships>
</file>

<file path=ppt/slides/_rels/slide2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6.xml"/><Relationship Id="rId3" Type="http://schemas.openxmlformats.org/officeDocument/2006/relationships/image" Target="../media/image42.png"/><Relationship Id="rId4" Type="http://schemas.openxmlformats.org/officeDocument/2006/relationships/image" Target="../media/image50.png"/></Relationships>
</file>

<file path=ppt/slides/_rels/slide2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7.xml"/><Relationship Id="rId3" Type="http://schemas.openxmlformats.org/officeDocument/2006/relationships/image" Target="../media/image46.png"/><Relationship Id="rId4" Type="http://schemas.openxmlformats.org/officeDocument/2006/relationships/image" Target="../media/image59.png"/></Relationships>
</file>

<file path=ppt/slides/_rels/slide2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8.xml"/><Relationship Id="rId3" Type="http://schemas.openxmlformats.org/officeDocument/2006/relationships/image" Target="../media/image61.png"/><Relationship Id="rId4" Type="http://schemas.openxmlformats.org/officeDocument/2006/relationships/image" Target="../media/image47.png"/></Relationships>
</file>

<file path=ppt/slides/_rels/slide2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9.xml"/><Relationship Id="rId3" Type="http://schemas.openxmlformats.org/officeDocument/2006/relationships/image" Target="../media/image57.png"/><Relationship Id="rId4" Type="http://schemas.openxmlformats.org/officeDocument/2006/relationships/image" Target="../media/image52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0.png"/><Relationship Id="rId4" Type="http://schemas.openxmlformats.org/officeDocument/2006/relationships/image" Target="../media/image7.png"/></Relationships>
</file>

<file path=ppt/slides/_rels/slide3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0.xml"/><Relationship Id="rId3" Type="http://schemas.openxmlformats.org/officeDocument/2006/relationships/image" Target="../media/image51.png"/><Relationship Id="rId4" Type="http://schemas.openxmlformats.org/officeDocument/2006/relationships/image" Target="../media/image53.png"/></Relationships>
</file>

<file path=ppt/slides/_rels/slide3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1.xml"/><Relationship Id="rId3" Type="http://schemas.openxmlformats.org/officeDocument/2006/relationships/image" Target="../media/image60.png"/><Relationship Id="rId4" Type="http://schemas.openxmlformats.org/officeDocument/2006/relationships/image" Target="../media/image55.png"/></Relationships>
</file>

<file path=ppt/slides/_rels/slide3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2.xml"/><Relationship Id="rId3" Type="http://schemas.openxmlformats.org/officeDocument/2006/relationships/image" Target="../media/image62.png"/><Relationship Id="rId4" Type="http://schemas.openxmlformats.org/officeDocument/2006/relationships/image" Target="../media/image54.png"/></Relationships>
</file>

<file path=ppt/slides/_rels/slide3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3.xml"/><Relationship Id="rId3" Type="http://schemas.openxmlformats.org/officeDocument/2006/relationships/image" Target="../media/image58.png"/><Relationship Id="rId4" Type="http://schemas.openxmlformats.org/officeDocument/2006/relationships/image" Target="../media/image56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3.png"/><Relationship Id="rId4" Type="http://schemas.openxmlformats.org/officeDocument/2006/relationships/image" Target="../media/image1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12.png"/><Relationship Id="rId4" Type="http://schemas.openxmlformats.org/officeDocument/2006/relationships/image" Target="../media/image19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22.png"/><Relationship Id="rId4" Type="http://schemas.openxmlformats.org/officeDocument/2006/relationships/image" Target="../media/image20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9.png"/><Relationship Id="rId4" Type="http://schemas.openxmlformats.org/officeDocument/2006/relationships/image" Target="../media/image5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1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g3628b36ef6a_0_0"/>
          <p:cNvSpPr txBox="1"/>
          <p:nvPr/>
        </p:nvSpPr>
        <p:spPr>
          <a:xfrm>
            <a:off x="1310500" y="1359775"/>
            <a:ext cx="99027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-190500" lvl="0" marL="190500" rtl="0" algn="just">
              <a:spcBef>
                <a:spcPts val="0"/>
              </a:spcBef>
              <a:spcAft>
                <a:spcPts val="0"/>
              </a:spcAft>
              <a:buNone/>
            </a:pPr>
            <a:r>
              <a:rPr lang="es-UY" sz="1800">
                <a:solidFill>
                  <a:schemeClr val="dk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Supplementary Figure 4. Circos plot obtained with Symap 5.0, comparing Dm28c and Dm25 strain. </a:t>
            </a:r>
            <a:endParaRPr sz="180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6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Google Shape;137;p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75204" y="321733"/>
            <a:ext cx="5697017" cy="61113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35115" y="440267"/>
            <a:ext cx="3627618" cy="616161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2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" name="Google Shape;143;p1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70416" y="279401"/>
            <a:ext cx="5432558" cy="5966354"/>
          </a:xfrm>
          <a:prstGeom prst="rect">
            <a:avLst/>
          </a:prstGeom>
          <a:noFill/>
          <a:ln>
            <a:noFill/>
          </a:ln>
        </p:spPr>
      </p:pic>
      <p:sp>
        <p:nvSpPr>
          <p:cNvPr id="144" name="Google Shape;144;p10"/>
          <p:cNvSpPr txBox="1"/>
          <p:nvPr/>
        </p:nvSpPr>
        <p:spPr>
          <a:xfrm>
            <a:off x="990600" y="6333067"/>
            <a:ext cx="4665133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 esta el Chr22_H1_c2 en ncbi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5" name="Google Shape;145;p1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20225" y="362449"/>
            <a:ext cx="3718708" cy="622038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9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Google Shape;150;p1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93725" y="556763"/>
            <a:ext cx="5172075" cy="5690578"/>
          </a:xfrm>
          <a:prstGeom prst="rect">
            <a:avLst/>
          </a:prstGeom>
          <a:noFill/>
          <a:ln>
            <a:noFill/>
          </a:ln>
        </p:spPr>
      </p:pic>
      <p:pic>
        <p:nvPicPr>
          <p:cNvPr id="151" name="Google Shape;151;p1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788014" y="220133"/>
            <a:ext cx="3887394" cy="657701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5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Google Shape;156;p1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61985" y="347132"/>
            <a:ext cx="5564895" cy="62992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57" name="Google Shape;157;p1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47079" y="81491"/>
            <a:ext cx="3904579" cy="656484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Google Shape;162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04814" y="457200"/>
            <a:ext cx="5981728" cy="60705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63" name="Google Shape;163;p1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527800" y="668653"/>
            <a:ext cx="5208087" cy="564769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7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8" name="Google Shape;168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67241" y="194733"/>
            <a:ext cx="5907954" cy="63674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69" name="Google Shape;169;p1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73758" y="414867"/>
            <a:ext cx="3701688" cy="61473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3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Google Shape;174;p1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51933" y="465666"/>
            <a:ext cx="5274792" cy="6063934"/>
          </a:xfrm>
          <a:prstGeom prst="rect">
            <a:avLst/>
          </a:prstGeom>
          <a:noFill/>
          <a:ln>
            <a:noFill/>
          </a:ln>
        </p:spPr>
      </p:pic>
      <p:pic>
        <p:nvPicPr>
          <p:cNvPr id="175" name="Google Shape;175;p1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053946" y="208068"/>
            <a:ext cx="3857470" cy="657912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9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Google Shape;180;p1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16875" y="711199"/>
            <a:ext cx="5370448" cy="5842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1" name="Google Shape;181;p1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20061" y="406400"/>
            <a:ext cx="3794001" cy="63119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85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Google Shape;186;p1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03250" y="380999"/>
            <a:ext cx="5386458" cy="6056312"/>
          </a:xfrm>
          <a:prstGeom prst="rect">
            <a:avLst/>
          </a:prstGeom>
          <a:noFill/>
          <a:ln>
            <a:noFill/>
          </a:ln>
        </p:spPr>
      </p:pic>
      <p:pic>
        <p:nvPicPr>
          <p:cNvPr id="187" name="Google Shape;187;p1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26123" y="448734"/>
            <a:ext cx="3664644" cy="608118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9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Google Shape;192;p1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66196" y="321733"/>
            <a:ext cx="5357159" cy="61520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93" name="Google Shape;193;p1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807200" y="134241"/>
            <a:ext cx="3967161" cy="652707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8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Google Shape;89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00037" y="268817"/>
            <a:ext cx="5800725" cy="64389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0" name="Google Shape;90;p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736292" y="762001"/>
            <a:ext cx="3816314" cy="566896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97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8" name="Google Shape;198;p1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73086" y="369696"/>
            <a:ext cx="5522913" cy="61327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9" name="Google Shape;199;p1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75107" y="737835"/>
            <a:ext cx="3333096" cy="539644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03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Google Shape;204;p2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00050" y="262467"/>
            <a:ext cx="5583526" cy="6144684"/>
          </a:xfrm>
          <a:prstGeom prst="rect">
            <a:avLst/>
          </a:prstGeom>
          <a:noFill/>
          <a:ln>
            <a:noFill/>
          </a:ln>
        </p:spPr>
      </p:pic>
      <p:pic>
        <p:nvPicPr>
          <p:cNvPr id="205" name="Google Shape;205;p2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306733" y="439109"/>
            <a:ext cx="3558115" cy="57914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09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" name="Google Shape;210;p2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84871" y="383178"/>
            <a:ext cx="5644530" cy="5915902"/>
          </a:xfrm>
          <a:prstGeom prst="rect">
            <a:avLst/>
          </a:prstGeom>
          <a:noFill/>
          <a:ln>
            <a:noFill/>
          </a:ln>
        </p:spPr>
      </p:pic>
      <p:pic>
        <p:nvPicPr>
          <p:cNvPr id="211" name="Google Shape;211;p2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016640" y="347490"/>
            <a:ext cx="3613124" cy="598727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15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6" name="Google Shape;216;p2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880534" y="533399"/>
            <a:ext cx="5219971" cy="5973233"/>
          </a:xfrm>
          <a:prstGeom prst="rect">
            <a:avLst/>
          </a:prstGeom>
          <a:noFill/>
          <a:ln>
            <a:noFill/>
          </a:ln>
        </p:spPr>
      </p:pic>
      <p:pic>
        <p:nvPicPr>
          <p:cNvPr id="217" name="Google Shape;217;p2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48020" y="458256"/>
            <a:ext cx="3736950" cy="612351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2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2" name="Google Shape;222;p2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24933" y="355599"/>
            <a:ext cx="5246511" cy="59023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23" name="Google Shape;223;p2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051002" y="584200"/>
            <a:ext cx="3521218" cy="589015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27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8" name="Google Shape;228;p2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33425" y="677332"/>
            <a:ext cx="4841683" cy="5393267"/>
          </a:xfrm>
          <a:prstGeom prst="rect">
            <a:avLst/>
          </a:prstGeom>
          <a:noFill/>
          <a:ln>
            <a:noFill/>
          </a:ln>
        </p:spPr>
      </p:pic>
      <p:pic>
        <p:nvPicPr>
          <p:cNvPr id="229" name="Google Shape;229;p2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775699" y="244737"/>
            <a:ext cx="3817454" cy="625845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33" name="Shape 2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4" name="Google Shape;234;p2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97417" y="821265"/>
            <a:ext cx="5564756" cy="58769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35" name="Google Shape;235;p2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44937" y="881591"/>
            <a:ext cx="3501368" cy="575627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39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0" name="Google Shape;240;p2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832908" y="719667"/>
            <a:ext cx="5223603" cy="5795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241" name="Google Shape;241;p2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039866" y="479160"/>
            <a:ext cx="3808579" cy="62769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45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6" name="Google Shape;246;p2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999068" y="524933"/>
            <a:ext cx="5181464" cy="5749922"/>
          </a:xfrm>
          <a:prstGeom prst="rect">
            <a:avLst/>
          </a:prstGeom>
          <a:noFill/>
          <a:ln>
            <a:noFill/>
          </a:ln>
        </p:spPr>
      </p:pic>
      <p:pic>
        <p:nvPicPr>
          <p:cNvPr id="247" name="Google Shape;247;p2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272866" y="292627"/>
            <a:ext cx="3807591" cy="621453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5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2" name="Google Shape;252;p2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81036" y="414865"/>
            <a:ext cx="5284599" cy="5856817"/>
          </a:xfrm>
          <a:prstGeom prst="rect">
            <a:avLst/>
          </a:prstGeom>
          <a:noFill/>
          <a:ln>
            <a:noFill/>
          </a:ln>
        </p:spPr>
      </p:pic>
      <p:pic>
        <p:nvPicPr>
          <p:cNvPr id="253" name="Google Shape;253;p2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12001" y="539530"/>
            <a:ext cx="3641196" cy="586814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4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Google Shape;95;p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73051" y="160867"/>
            <a:ext cx="5669526" cy="6276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96" name="Google Shape;96;p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37400" y="499532"/>
            <a:ext cx="3487737" cy="586142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57" name="Shape 2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8" name="Google Shape;258;p29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701674" y="741362"/>
            <a:ext cx="5202298" cy="5701771"/>
          </a:xfrm>
          <a:prstGeom prst="rect">
            <a:avLst/>
          </a:prstGeom>
          <a:noFill/>
          <a:ln>
            <a:noFill/>
          </a:ln>
        </p:spPr>
      </p:pic>
      <p:pic>
        <p:nvPicPr>
          <p:cNvPr id="259" name="Google Shape;259;p29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985000" y="429896"/>
            <a:ext cx="3822171" cy="632470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63" name="Shape 2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4" name="Google Shape;264;p30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966535" y="665585"/>
            <a:ext cx="4763705" cy="5337281"/>
          </a:xfrm>
          <a:prstGeom prst="rect">
            <a:avLst/>
          </a:prstGeom>
          <a:noFill/>
          <a:ln>
            <a:noFill/>
          </a:ln>
        </p:spPr>
      </p:pic>
      <p:pic>
        <p:nvPicPr>
          <p:cNvPr id="265" name="Google Shape;265;p30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743240" y="259291"/>
            <a:ext cx="3764952" cy="614986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69" name="Shape 2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0" name="Google Shape;270;p3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678392" y="237065"/>
            <a:ext cx="5656964" cy="6294967"/>
          </a:xfrm>
          <a:prstGeom prst="rect">
            <a:avLst/>
          </a:prstGeom>
          <a:noFill/>
          <a:ln>
            <a:noFill/>
          </a:ln>
        </p:spPr>
      </p:pic>
      <p:pic>
        <p:nvPicPr>
          <p:cNvPr id="271" name="Google Shape;271;p31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07434" y="358769"/>
            <a:ext cx="3687565" cy="605155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75" name="Shape 2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" name="Google Shape;276;p3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60892" y="440267"/>
            <a:ext cx="5633183" cy="6192308"/>
          </a:xfrm>
          <a:prstGeom prst="rect">
            <a:avLst/>
          </a:prstGeom>
          <a:noFill/>
          <a:ln>
            <a:noFill/>
          </a:ln>
        </p:spPr>
      </p:pic>
      <p:pic>
        <p:nvPicPr>
          <p:cNvPr id="277" name="Google Shape;277;p3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59339" y="513027"/>
            <a:ext cx="3609729" cy="604678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0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Google Shape;101;p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92654" y="380999"/>
            <a:ext cx="5425914" cy="6282268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" name="Google Shape;102;p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938720" y="194732"/>
            <a:ext cx="3754680" cy="644565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6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Google Shape;107;p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96332" y="110066"/>
            <a:ext cx="5663865" cy="64103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8" name="Google Shape;108;p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938754" y="1016000"/>
            <a:ext cx="3236064" cy="536045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2" name="Shape 1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Google Shape;113;p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22288" y="609599"/>
            <a:ext cx="5247760" cy="596000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4" name="Google Shape;114;p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827381" y="194733"/>
            <a:ext cx="3871309" cy="659129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8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Google Shape;119;p6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85247" y="228600"/>
            <a:ext cx="5649642" cy="64447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6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7170243" y="503237"/>
            <a:ext cx="3624757" cy="617008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4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Google Shape;125;p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34987" y="397933"/>
            <a:ext cx="5285373" cy="60071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7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417733" y="231978"/>
            <a:ext cx="3747028" cy="633900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0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Google Shape;131;p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03213" y="592667"/>
            <a:ext cx="5356108" cy="58224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2" name="Google Shape;132;p8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6790146" y="0"/>
            <a:ext cx="3922832" cy="668549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5-13T14:55:17Z</dcterms:created>
  <dc:creator>Gonzalo Greif</dc:creator>
</cp:coreProperties>
</file>